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1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14854-2366-42DC-919E-5398AF429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223AF4-D0B5-4B06-B1B3-B6CDD3CE9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C13E0F-72A6-4836-9FB6-2CCE71DC5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B93265-0CA2-489F-B26C-30554C1F9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E031FE-F034-404C-98F7-53B1F91E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7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6DD85-7225-4129-A0EA-ABA537AFA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742D90-7F90-41AF-9955-7A447CF95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CBB780-D715-4560-9627-D3916E84D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2C4DD2-13C1-48F7-8649-D5C896FBD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E91BE3-4F20-4EA3-9292-E5F700A07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984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3A359DA-3821-472C-B808-E26F0C960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BC5386-2201-4D23-B99A-895FAA136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B63896-02C1-471B-84F1-31D084251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81D391-8AE8-4783-A8EC-0FDADAFF4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E1AD23-5C77-4CD0-90DA-DB71EFE0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15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5EBF0-33F4-4E3D-B65B-21CAFF1FC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7966FC-FD61-451D-8192-BA34CBD94C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8A9433-6059-42B6-A1AA-7AF49466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212271-6B32-47DF-9DB6-CE212152F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58B159-B0F9-45F9-AABB-03E489A0A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64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34D14-1529-4444-A80D-FE016B6F2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7AE081-8C41-4BB2-A798-EC0FC943D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817311-81CD-49E6-8240-29A3341AC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46764C-7B56-4967-9EB0-5AFCC4170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AE704C-EA7C-4D40-B17A-B43F717FD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055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FDA63A-35D6-4DD9-AFE7-3FA320358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EE4AE5-EDAA-4933-B31C-9A288F278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AAB566-7F61-4A6A-96AC-B241034C7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6AA141-FC99-4EA5-9ACF-B58984A48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5728C0-ABD3-4D94-B883-1EA1AD484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C196A1-6207-453F-83F3-511005191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059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C9C572-9AA9-4524-8516-FD974A210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916BD6-7E8B-40B8-80C8-397F4BDFC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E92ECB-6BCB-4CFC-A330-3BA1001C2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CD6CF56-A11C-44E7-842D-DF50661A63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2CBAC0-80C1-4C8F-B3CA-DA33870DC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61D00BB-04F6-45AA-821B-E5BFB61A1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65DCB0D-5AC7-4CD2-BC60-F286C3D6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3A3EB3-59F3-4082-B038-A93C9CBD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115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15D701-5C7A-4C6F-8F69-99E1E6BEA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43AB703-B586-46E3-A790-D97B400CB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887F5F-436F-4CC6-B856-535CD899E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3B1E434-A5BF-4FBA-8224-1218D3295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08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DA7A90-EA32-46B6-94D9-22A5AF5DF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65CF67-E95F-466A-830C-8FDEBF6D4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4814E32-EDE5-474F-9ED5-950392FC2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713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D1F648-EB8A-4E25-A571-BC539C8F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39E0C0-7D2A-4A5C-8700-0E1F3D12CE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956C8-DC56-4727-A7EA-5E70463E2B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9F76A0-51CD-47E2-8B85-FB20A67AA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89DE49-6901-43FC-B801-A4A217BD6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A615B1A-E94A-43F4-AFF2-EE6245B41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30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D1BB2A-CD43-4742-9D71-FA62BA3FD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D806BB-0AAE-4032-8530-4E31516207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F8DE99-9E0F-4492-B23B-23EFD9D3B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C05EE-40C4-479A-98C9-DFB38DF5A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6F9542-8116-4DEB-964C-8A93F456F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9141C4-C488-4998-8350-6DDE9F5F4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41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DE41ED-680D-4531-88EF-B0693126B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21DB1F-AE5E-47B4-B9FE-58D56987B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D346E6-3A47-4C4E-BDFC-6723CFD340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C40DB9-29F5-4560-A2C3-88CDDCB926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BE74E0-0162-42C4-B72F-B4ADDFB7EF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181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D93A49C-4E28-41F6-A344-C9BD16AE10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1028700"/>
            <a:ext cx="8134350" cy="4800600"/>
          </a:xfrm>
          <a:prstGeom prst="rect">
            <a:avLst/>
          </a:prstGeom>
        </p:spPr>
      </p:pic>
      <p:sp>
        <p:nvSpPr>
          <p:cNvPr id="3" name="Rectangle 97">
            <a:extLst>
              <a:ext uri="{FF2B5EF4-FFF2-40B4-BE49-F238E27FC236}">
                <a16:creationId xmlns:a16="http://schemas.microsoft.com/office/drawing/2014/main" id="{8945C69C-64C1-4571-8DFE-1E154C697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3739" y="3481779"/>
            <a:ext cx="10493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 </a:t>
            </a:r>
            <a:r>
              <a:rPr lang="en-US" altLang="ja-JP" sz="1800" b="1" i="1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P </a:t>
            </a:r>
            <a:r>
              <a:rPr lang="en-US" altLang="ja-JP" sz="1800" b="1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= 0.046</a:t>
            </a:r>
            <a:endParaRPr lang="ja-JP" altLang="en-US" sz="1800" b="1" u="none" strike="noStrike" baseline="0" dirty="0">
              <a:solidFill>
                <a:srgbClr val="000000"/>
              </a:solidFill>
              <a:latin typeface="Arial" panose="020B0604020202020204" pitchFamily="34" charset="0"/>
              <a:ea typeface="MS UI Gothic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F92D1FA-5F99-4A79-80F1-20E3E7D88A5D}"/>
              </a:ext>
            </a:extLst>
          </p:cNvPr>
          <p:cNvSpPr txBox="1"/>
          <p:nvPr/>
        </p:nvSpPr>
        <p:spPr>
          <a:xfrm>
            <a:off x="1371602" y="5393487"/>
            <a:ext cx="1847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35DC6D0-F967-43A3-A705-EF695B5AE1A1}"/>
              </a:ext>
            </a:extLst>
          </p:cNvPr>
          <p:cNvSpPr txBox="1"/>
          <p:nvPr/>
        </p:nvSpPr>
        <p:spPr>
          <a:xfrm>
            <a:off x="1371602" y="5810338"/>
            <a:ext cx="6898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0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r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42           23          13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2            2            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F4F637-1FC4-4333-8C20-40153E893377}"/>
              </a:ext>
            </a:extLst>
          </p:cNvPr>
          <p:cNvSpPr txBox="1"/>
          <p:nvPr/>
        </p:nvSpPr>
        <p:spPr>
          <a:xfrm>
            <a:off x="1732898" y="6182965"/>
            <a:ext cx="67794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2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17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107D7D01-79D3-41C5-94C9-40927D80D8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4389" y="2115668"/>
            <a:ext cx="573074" cy="377985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E140C63-09BB-4D5C-B578-9FD72984324A}"/>
              </a:ext>
            </a:extLst>
          </p:cNvPr>
          <p:cNvSpPr txBox="1"/>
          <p:nvPr/>
        </p:nvSpPr>
        <p:spPr>
          <a:xfrm>
            <a:off x="0" y="0"/>
            <a:ext cx="12192000" cy="1115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3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ime to treatment failure in patients with unresectable or metastatic biliary tract cancer receiving gemcitabine plus cisplatin based on the modified Glasgow Prognostic Score (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GP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; 0–1 vs. 2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5658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67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司弥生</dc:creator>
  <cp:lastModifiedBy>KAZUMA FUJITA</cp:lastModifiedBy>
  <cp:revision>18</cp:revision>
  <dcterms:created xsi:type="dcterms:W3CDTF">2024-07-04T09:22:40Z</dcterms:created>
  <dcterms:modified xsi:type="dcterms:W3CDTF">2025-12-05T04:35:13Z</dcterms:modified>
</cp:coreProperties>
</file>